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jpeg" ContentType="image/jpe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17CC7E-09D8-497C-BFFF-773FF47EC44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295386-A201-42B8-A2BD-F3D617B3BB2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B20DC6-DAA3-468D-9BF4-71353AB26EC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325CCD-44D4-4BAF-A406-375AAA8ED02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2EDB50-5D67-4DDB-9C5B-C8ACC5E5B31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51B571-7660-4AF8-9504-48131BBFCE5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1B020A-868D-47A5-8FCD-99DB068562A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0FA271-33DF-4D38-AAF7-3BFB0E90DC9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28194C-4908-46C4-BC18-A54F6E7E829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DDD0E0-3EFC-414E-B4C5-86075A05F96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2D5E96-05B2-4F8D-99B0-54950A601C4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AFC75B-7FC1-478D-84FB-D48E533D483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35C3283-3DDA-41F7-B620-B2455AAC0C54}" type="slidenum">
              <a:rPr b="0" lang="es-E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631800" y="4533840"/>
            <a:ext cx="4759920" cy="4002480"/>
            <a:chOff x="631800" y="4533840"/>
            <a:chExt cx="4759920" cy="4002480"/>
          </a:xfrm>
        </p:grpSpPr>
        <p:grpSp>
          <p:nvGrpSpPr>
            <p:cNvPr id="42" name=""/>
            <p:cNvGrpSpPr/>
            <p:nvPr/>
          </p:nvGrpSpPr>
          <p:grpSpPr>
            <a:xfrm>
              <a:off x="631800" y="4533840"/>
              <a:ext cx="4759920" cy="4002480"/>
              <a:chOff x="631800" y="4533840"/>
              <a:chExt cx="4759920" cy="4002480"/>
            </a:xfrm>
          </p:grpSpPr>
          <p:pic>
            <p:nvPicPr>
              <p:cNvPr id="43" name="" descr=""/>
              <p:cNvPicPr/>
              <p:nvPr/>
            </p:nvPicPr>
            <p:blipFill>
              <a:blip r:embed="rId1"/>
              <a:stretch/>
            </p:blipFill>
            <p:spPr>
              <a:xfrm>
                <a:off x="3191040" y="4903920"/>
                <a:ext cx="475920" cy="4759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4" name="" descr=""/>
              <p:cNvPicPr/>
              <p:nvPr/>
            </p:nvPicPr>
            <p:blipFill>
              <a:blip r:embed="rId2"/>
              <a:srcRect l="21971" t="23686" r="23139" b="33765"/>
              <a:stretch/>
            </p:blipFill>
            <p:spPr>
              <a:xfrm>
                <a:off x="1554120" y="4533840"/>
                <a:ext cx="3552840" cy="25560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5" name=""/>
              <p:cNvSpPr/>
              <p:nvPr/>
            </p:nvSpPr>
            <p:spPr>
              <a:xfrm>
                <a:off x="631800" y="7071840"/>
                <a:ext cx="2057400" cy="1464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Arial Unicode MS"/>
                  </a:rPr>
                  <a:t>UDP-N-acetylglucosamine:LPS N-acetylglucosamine transferas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000" spc="-1" strike="noStrike">
                    <a:solidFill>
                      <a:srgbClr val="000000"/>
                    </a:solidFill>
                    <a:latin typeface="Arial Unicode MS"/>
                  </a:rPr>
                  <a:t>alpha-proteobacteria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Arial Unicode MS"/>
                  </a:rPr>
                  <a:t>(</a:t>
                </a:r>
                <a:r>
                  <a:rPr b="0" i="1" lang="es-ES" sz="1000" spc="-1" strike="noStrike">
                    <a:solidFill>
                      <a:srgbClr val="000000"/>
                    </a:solidFill>
                    <a:latin typeface="Arial Unicode MS"/>
                  </a:rPr>
                  <a:t>Magnetospirillum, Xanthobacter</a:t>
                </a:r>
                <a:r>
                  <a:rPr b="0" i="1" lang="es-ES" sz="1000" spc="-1" strike="noStrike">
                    <a:solidFill>
                      <a:srgbClr val="000000"/>
                    </a:solidFill>
                    <a:latin typeface="Arial"/>
                  </a:rPr>
                  <a:t>, Parvibaculum</a:t>
                </a:r>
                <a:r>
                  <a:rPr b="0" lang="es-ES" sz="1000" spc="-1" strike="noStrike">
                    <a:solidFill>
                      <a:srgbClr val="000000"/>
                    </a:solidFill>
                    <a:latin typeface="Arial"/>
                  </a:rPr>
                  <a:t>, etc.)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>
                <a:off x="2676600" y="7300800"/>
                <a:ext cx="2047680" cy="861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Arial Unicode MS"/>
                  </a:rPr>
                  <a:t>Transposas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000" spc="-1" strike="noStrike">
                    <a:solidFill>
                      <a:srgbClr val="000000"/>
                    </a:solidFill>
                    <a:latin typeface="Arial Unicode MS"/>
                  </a:rPr>
                  <a:t>alpha-proteobacteria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Arial Unicode MS"/>
                  </a:rPr>
                  <a:t>(</a:t>
                </a:r>
                <a:r>
                  <a:rPr b="0" i="1" lang="es-ES" sz="1000" spc="-1" strike="noStrike">
                    <a:solidFill>
                      <a:srgbClr val="000000"/>
                    </a:solidFill>
                    <a:latin typeface="Arial Unicode MS"/>
                  </a:rPr>
                  <a:t>Nitrobacter, Brucella, Salicibacter</a:t>
                </a:r>
                <a:r>
                  <a:rPr b="0" lang="es-ES" sz="1000" spc="-1" strike="noStrike">
                    <a:solidFill>
                      <a:srgbClr val="000000"/>
                    </a:solidFill>
                    <a:latin typeface="Arial Unicode MS"/>
                  </a:rPr>
                  <a:t>, etc.)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3677760" y="5498640"/>
                <a:ext cx="1713960" cy="855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Arial Unicode MS"/>
                  </a:rPr>
                  <a:t>Hypothetical protein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000" spc="-1" strike="noStrike">
                    <a:solidFill>
                      <a:srgbClr val="000000"/>
                    </a:solidFill>
                    <a:latin typeface="Arial Unicode MS"/>
                  </a:rPr>
                  <a:t>gamma-proteobacteria?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Arial Unicode MS"/>
                  </a:rPr>
                  <a:t>(</a:t>
                </a:r>
                <a:r>
                  <a:rPr b="0" i="1" lang="es-ES" sz="1000" spc="-1" strike="noStrike">
                    <a:solidFill>
                      <a:srgbClr val="000000"/>
                    </a:solidFill>
                    <a:latin typeface="Arial Unicode MS"/>
                  </a:rPr>
                  <a:t>Acinetobacter</a:t>
                </a:r>
                <a:r>
                  <a:rPr b="0" lang="es-ES" sz="1000" spc="-1" strike="noStrike">
                    <a:solidFill>
                      <a:srgbClr val="000000"/>
                    </a:solidFill>
                    <a:latin typeface="Arial Unicode MS"/>
                  </a:rPr>
                  <a:t>)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2133720" y="7027920"/>
                <a:ext cx="56880" cy="209520"/>
              </a:xfrm>
              <a:prstGeom prst="downArrow">
                <a:avLst>
                  <a:gd name="adj1" fmla="val 50000"/>
                  <a:gd name="adj2" fmla="val 92089"/>
                </a:avLst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3216240" y="7120080"/>
                <a:ext cx="57240" cy="180720"/>
              </a:xfrm>
              <a:prstGeom prst="downArrow">
                <a:avLst>
                  <a:gd name="adj1" fmla="val 50000"/>
                  <a:gd name="adj2" fmla="val 78931"/>
                </a:avLst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4299120" y="5268960"/>
                <a:ext cx="56880" cy="180720"/>
              </a:xfrm>
              <a:prstGeom prst="downArrow">
                <a:avLst>
                  <a:gd name="adj1" fmla="val 50000"/>
                  <a:gd name="adj2" fmla="val 79430"/>
                </a:avLst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1" name=""/>
            <p:cNvSpPr/>
            <p:nvPr/>
          </p:nvSpPr>
          <p:spPr>
            <a:xfrm>
              <a:off x="919440" y="4921200"/>
              <a:ext cx="333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2" name=""/>
          <p:cNvGrpSpPr/>
          <p:nvPr/>
        </p:nvGrpSpPr>
        <p:grpSpPr>
          <a:xfrm>
            <a:off x="843120" y="623880"/>
            <a:ext cx="4170240" cy="3587760"/>
            <a:chOff x="843120" y="623880"/>
            <a:chExt cx="4170240" cy="3587760"/>
          </a:xfrm>
        </p:grpSpPr>
        <p:pic>
          <p:nvPicPr>
            <p:cNvPr id="53" name="" descr=""/>
            <p:cNvPicPr/>
            <p:nvPr/>
          </p:nvPicPr>
          <p:blipFill>
            <a:blip r:embed="rId3"/>
            <a:stretch/>
          </p:blipFill>
          <p:spPr>
            <a:xfrm>
              <a:off x="1484280" y="682560"/>
              <a:ext cx="3529080" cy="3529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4" name=""/>
            <p:cNvSpPr/>
            <p:nvPr/>
          </p:nvSpPr>
          <p:spPr>
            <a:xfrm>
              <a:off x="843120" y="1071360"/>
              <a:ext cx="333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1857240" y="623880"/>
              <a:ext cx="571680" cy="88920"/>
            </a:xfrm>
            <a:custGeom>
              <a:avLst/>
              <a:gdLst>
                <a:gd name="textAreaLeft" fmla="*/ 0 w 571680"/>
                <a:gd name="textAreaRight" fmla="*/ 572040 w 571680"/>
                <a:gd name="textAreaTop" fmla="*/ 0 h 88920"/>
                <a:gd name="textAreaBottom" fmla="*/ 89280 h 889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6200" y="0"/>
                  </a:lnTo>
                  <a:lnTo>
                    <a:pt x="21600" y="10800"/>
                  </a:lnTo>
                  <a:lnTo>
                    <a:pt x="1620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2480" bIns="424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2882880" y="628560"/>
              <a:ext cx="714240" cy="79200"/>
            </a:xfrm>
            <a:custGeom>
              <a:avLst/>
              <a:gdLst>
                <a:gd name="textAreaLeft" fmla="*/ 0 w 714240"/>
                <a:gd name="textAreaRight" fmla="*/ 714600 w 714240"/>
                <a:gd name="textAreaTop" fmla="*/ 0 h 79200"/>
                <a:gd name="textAreaBottom" fmla="*/ 79560 h 792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6200" y="0"/>
                  </a:lnTo>
                  <a:lnTo>
                    <a:pt x="21600" y="10800"/>
                  </a:lnTo>
                  <a:lnTo>
                    <a:pt x="1620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2760" bIns="327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3670200" y="628560"/>
              <a:ext cx="1104840" cy="79200"/>
            </a:xfrm>
            <a:custGeom>
              <a:avLst/>
              <a:gdLst>
                <a:gd name="textAreaLeft" fmla="*/ 0 w 1104840"/>
                <a:gd name="textAreaRight" fmla="*/ 1105200 w 1104840"/>
                <a:gd name="textAreaTop" fmla="*/ 0 h 79200"/>
                <a:gd name="textAreaBottom" fmla="*/ 79560 h 792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6200" y="0"/>
                  </a:lnTo>
                  <a:lnTo>
                    <a:pt x="21600" y="10800"/>
                  </a:lnTo>
                  <a:lnTo>
                    <a:pt x="1620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2760" bIns="327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8" name=""/>
          <p:cNvSpPr/>
          <p:nvPr/>
        </p:nvSpPr>
        <p:spPr>
          <a:xfrm>
            <a:off x="1861920" y="366840"/>
            <a:ext cx="51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ORF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2935080" y="366840"/>
            <a:ext cx="51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ORF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3865320" y="366840"/>
            <a:ext cx="51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ORF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4-15T08:21:25Z</dcterms:created>
  <dc:creator>Javier Tamames</dc:creator>
  <dc:description/>
  <dc:language>en-US</dc:language>
  <cp:lastModifiedBy>heatherw</cp:lastModifiedBy>
  <dcterms:modified xsi:type="dcterms:W3CDTF">2008-04-16T10:01:05Z</dcterms:modified>
  <cp:revision>6</cp:revision>
  <dc:subject/>
  <dc:title>Diapositiva 1</dc:title>
</cp:coreProperties>
</file>